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238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F01BA7-6092-4455-B7F8-319C2F36B389}" type="datetimeFigureOut">
              <a:rPr lang="zh-CN" altLang="en-US" smtClean="0"/>
              <a:t>2014-1-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6525CD-4ED6-418C-AC23-54C76EE14BD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FFEE9-D0AC-4860-9FA0-B93A8515CEAC}" type="datetimeFigureOut">
              <a:rPr lang="zh-CN" altLang="en-US" smtClean="0"/>
              <a:pPr/>
              <a:t>2014-1-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10184-55BD-4949-978A-6EF78D965BF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384300" y="69850"/>
          <a:ext cx="3398838" cy="9052560"/>
        </p:xfrm>
        <a:graphic>
          <a:graphicData uri="http://schemas.openxmlformats.org/drawingml/2006/table">
            <a:tbl>
              <a:tblPr/>
              <a:tblGrid>
                <a:gridCol w="742950"/>
                <a:gridCol w="2655888"/>
              </a:tblGrid>
              <a:tr h="1603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Gene name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primers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62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O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TCGCATATGCCCCGGTCGG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 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GCAACCAGTCGGGTTCCGG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C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TGCATGGCGATGTGGTAGTT 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TAAGGCCGCGGAAGAAAG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M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CCAATGCGGCCGTTGT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 TGAGAAAAACGACGCAATGA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P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GGCCATATCCGCGAGCTT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宋体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CGCATGACCACATCCCAAT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D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CACCATCACCAACATGCAC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 CTGGATCGATGATGAAGGC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R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F: 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GCACCCTGTCTTCCCTA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66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: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 CTGGTCTTCCTCATCCAC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62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</a:t>
                      </a: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S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CGAGTCGCTCAGGCGCTCAA 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231F20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GCTCAGACTGACCGCCGCTC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52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宋体" charset="-122"/>
                          <a:cs typeface="Arial" charset="0"/>
                        </a:rPr>
                        <a:t>b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-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t</a:t>
                      </a: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ubulin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CCAAGAACATGATGGCTGCT   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Symbol" pitchFamily="18" charset="2"/>
                        <a:ea typeface="宋体" charset="-122"/>
                        <a:cs typeface="Arial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CTTGAAGAGCTCCTGGATGG </a:t>
                      </a:r>
                      <a:r>
                        <a:rPr kumimoji="0" lang="en-US" altLang="zh-CN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    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62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flU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CGGCGGTCCCTCTTTTCCCG;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TGCGTCGTGAGGTCGGAGGT;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76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n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ad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ACGGAGAAGGTCCGTCCGGG;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3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CCTCACGCGCACGACACAGT;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h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xt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GCAGGCGTGGAACGCAGTCT;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66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ATGCGACAACCGCACTGCC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g</a:t>
                      </a: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lc</a:t>
                      </a:r>
                      <a:r>
                        <a:rPr kumimoji="0" lang="en-US" altLang="zh-CN" sz="900" b="0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A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GCGCCCATCACCGACCCAAA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GCGGTCAAAGCCCACTGCCT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698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s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ug</a:t>
                      </a:r>
                      <a:r>
                        <a:rPr kumimoji="0" lang="en-US" altLang="zh-CN" sz="9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R</a:t>
                      </a: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F: CCCTTGTGTGCACCGCAACCCA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Times New Roman" pitchFamily="18" charset="0"/>
                        </a:rPr>
                        <a:t>R: CGTTCAGCCGGGGAAAGCGA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kern="1200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kojA</a:t>
                      </a:r>
                      <a:endParaRPr kumimoji="0" lang="zh-CN" altLang="zh-CN" sz="900" b="0" i="1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F: ACACAAACGAGCCCCCTTCAG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R: CCTCGTGACGGTCGAATGA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kern="1200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kojR</a:t>
                      </a:r>
                      <a:endParaRPr kumimoji="0" lang="zh-CN" altLang="zh-CN" sz="900" b="0" i="1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F: CAACTCAGGCACCGCTTTC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R: TCCAGCTAAACCCGTACACCTT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1" u="none" strike="noStrike" kern="1200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Times New Roman" pitchFamily="18" charset="0"/>
                        </a:rPr>
                        <a:t>kojT</a:t>
                      </a:r>
                      <a:endParaRPr kumimoji="0" lang="zh-CN" altLang="zh-CN" sz="900" b="0" i="1" u="none" strike="noStrike" kern="1200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F: TTTGGAGGATGCCGACGAT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zh-CN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宋体" charset="-122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2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Arial" charset="0"/>
                          <a:cs typeface="Times New Roman" pitchFamily="18" charset="0"/>
                        </a:rPr>
                        <a:t>R: TTCCTGGCGTGGAGTATGG</a:t>
                      </a:r>
                      <a:endParaRPr kumimoji="0" lang="zh-CN" altLang="zh-CN" sz="9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Arial" charset="0"/>
                        <a:cs typeface="Times New Roman" pitchFamily="18" charset="0"/>
                      </a:endParaRPr>
                    </a:p>
                  </a:txBody>
                  <a:tcPr marL="19004" marR="19004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343" name="TextBox 4"/>
          <p:cNvSpPr txBox="1">
            <a:spLocks noChangeArrowheads="1"/>
          </p:cNvSpPr>
          <p:nvPr/>
        </p:nvSpPr>
        <p:spPr bwMode="auto">
          <a:xfrm>
            <a:off x="0" y="122238"/>
            <a:ext cx="17970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1"/>
              <a:t>Additional file 2</a:t>
            </a:r>
            <a:endParaRPr lang="zh-CN" altLang="en-US" sz="1200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3</Words>
  <Application>Microsoft Office PowerPoint</Application>
  <PresentationFormat>全屏显示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Lenovo (Beijing) Limite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 User</dc:creator>
  <cp:lastModifiedBy>Lenovo User</cp:lastModifiedBy>
  <cp:revision>4</cp:revision>
  <dcterms:created xsi:type="dcterms:W3CDTF">2013-10-15T08:08:20Z</dcterms:created>
  <dcterms:modified xsi:type="dcterms:W3CDTF">2014-01-23T02:25:40Z</dcterms:modified>
</cp:coreProperties>
</file>